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14AEEA-44F8-3049-A579-1CAFECFA89B3}" type="datetimeFigureOut">
              <a:rPr lang="en-US" smtClean="0"/>
              <a:t>7/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E0C2C1-ECCA-7A4F-80BB-02924371C3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3270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6A4774-7F3E-4567-9182-FBAFAB6D6F4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5596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6A4774-7F3E-4567-9182-FBAFAB6D6F4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468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E73097-E11A-B36E-66A6-03530696BB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022D44-16A8-413B-37CD-A8725660F5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14E98-ED71-DDCB-3CBE-7BC181EFD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BF25AB-B397-918B-E585-54F56AE0A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48E00-CF10-81E2-A394-CF2C61BC1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361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C8D376-FEE5-C954-4ABB-59A963304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D7CDEC-7D0A-5868-6A88-8182999C6E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89EFA-5471-619F-988A-EE47F9C91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3E769-9E7B-1BAE-774A-B66E4D5B4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7A7A4-C374-9FA9-3FCB-69F951269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263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AB234C-E589-72A8-6639-2C5316D827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687746-354A-C6DA-24F8-C05B27A8D6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B07D7-EF30-82BB-BD82-FF095F543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0A321-FF92-8CE0-37F2-AAF003A0C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40C2A0-43AC-CB5C-671F-F1761656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533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989A1-84FC-5896-377B-33A025BD7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A0C2CD-F316-8F4A-889F-B4748546ED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4E6EB-C8EE-17CB-DB6E-8EB9686F2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54FA89-2A0E-58BD-9915-9618007BF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BE0951-987F-DB91-F56B-AA970D83C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00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7FCEE-EA56-764E-036B-9B69B30C5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696015-DFC8-09A8-DF83-D0EDD3CB9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138CB9-C468-671E-CD0E-F6D6AA02D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68B948-ECE1-F31B-B9D1-638853411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F56D76-72E3-F87E-BC56-298C2E123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696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04DA2C-53E3-4F9C-D018-CB02B1683E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32086F-3A40-43DE-DEE3-CB91864896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F82D14-02E6-6C14-B449-E550E06489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B74E30-65EB-9A2A-643E-A78CBAA86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D2B7F9-6A3B-AA81-E4BD-EF5CB572C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8607F7-7541-3B27-8419-49157238D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24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226E96-F32A-5DA0-B196-AA961F004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E62A2C-D98B-CAAF-1323-DDBD5C689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D4530F-A723-2D78-DC0E-1D893C44A3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A0DE87-2DD0-2D0F-A684-0E1D0AA895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7699EC-8801-14D0-F883-037ED09D9E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2ED6C8-842D-5270-8B47-3330042B1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DEA3F5-1BED-7CD9-3607-74E39DDCAA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80E59B-88DB-5D2F-CDED-E1CA27BF6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887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FCF712-8E5D-A59B-6196-F38E3CD7D8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FEA134-A29A-AD1A-0CC0-97E277D51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B428A2-B61F-C180-CCB8-2E3BC6E0B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06BBCC-1C0B-1FAC-6E6E-86E53EE76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723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FB24DD9-1F5D-2099-6D5F-6F50FCF67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6E109F-6DEE-FA09-E2DD-87545354F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8146AC-0055-8F83-C7EB-58919CEF7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713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F4E51-A9C6-89B1-4A44-C47C477C8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EB8C73-B891-DD65-3644-EE4AA7A3F0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DEE6E8-25C1-E8F1-C3A2-97B7ECEA6B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53198F-EF47-8131-DB60-4F0FDC9E6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DEE430-FFF8-EBAC-42EB-EFEC24975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7B88A9-63A0-3C37-7A7F-3FB69D6C7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801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79DE7-5E31-296B-0CEE-C4993DF37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5DAAD1-5B95-2170-5049-80C9012E79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193884-2E8D-6D21-D298-829DA30621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C00EF5-1CBC-62E5-9515-E3D6625AD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232856-550B-AB78-D570-3A3DA7403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4F325-60E0-8188-DB26-27C39CA33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06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21809B0-CEE0-EBBC-1EA8-730F4F11E9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6EA8F8-2C10-FA20-F84F-72FD2B8FEA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3E912-2876-3086-10A3-1825EBDBD4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5025A-0346-1C47-BC70-E347CB439696}" type="datetimeFigureOut">
              <a:rPr lang="en-US" smtClean="0"/>
              <a:t>7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623D38-614F-D658-9A91-8233895525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5ACED-C19F-EA23-CD6D-AB96142741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80F09-8CD7-C645-A12F-821197CA4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419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37258C18-D05D-409F-A2AF-0CBF686442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23" y="0"/>
            <a:ext cx="6172199" cy="3429000"/>
          </a:xfrm>
          <a:prstGeom prst="rect">
            <a:avLst/>
          </a:prstGeom>
        </p:spPr>
      </p:pic>
      <p:pic>
        <p:nvPicPr>
          <p:cNvPr id="5" name="Picture 4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50331A8D-027F-4272-8E24-7E24454682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22" y="3429000"/>
            <a:ext cx="6172200" cy="3429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92BA24A-0B8B-4DF8-B54C-20532B5FF09C}"/>
              </a:ext>
            </a:extLst>
          </p:cNvPr>
          <p:cNvSpPr txBox="1"/>
          <p:nvPr/>
        </p:nvSpPr>
        <p:spPr>
          <a:xfrm>
            <a:off x="0" y="15389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8E46FC-2380-4EB3-9A6A-5654BF85A763}"/>
              </a:ext>
            </a:extLst>
          </p:cNvPr>
          <p:cNvSpPr txBox="1"/>
          <p:nvPr/>
        </p:nvSpPr>
        <p:spPr>
          <a:xfrm>
            <a:off x="-1" y="3444389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0EA588-8639-6F51-DA8C-13933555DA76}"/>
              </a:ext>
            </a:extLst>
          </p:cNvPr>
          <p:cNvSpPr txBox="1"/>
          <p:nvPr/>
        </p:nvSpPr>
        <p:spPr>
          <a:xfrm>
            <a:off x="8719575" y="0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455005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E6E90215-7F08-48B3-AAF6-BCD1192AE899}"/>
              </a:ext>
            </a:extLst>
          </p:cNvPr>
          <p:cNvGrpSpPr/>
          <p:nvPr/>
        </p:nvGrpSpPr>
        <p:grpSpPr>
          <a:xfrm>
            <a:off x="346927" y="284830"/>
            <a:ext cx="5024134" cy="4228001"/>
            <a:chOff x="339394" y="-1"/>
            <a:chExt cx="3302717" cy="277936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394" y="-1"/>
              <a:ext cx="3302717" cy="2779363"/>
            </a:xfrm>
            <a:prstGeom prst="rect">
              <a:avLst/>
            </a:prstGeom>
          </p:spPr>
        </p:pic>
        <p:sp>
          <p:nvSpPr>
            <p:cNvPr id="8" name="Arrow: Right 7">
              <a:extLst>
                <a:ext uri="{FF2B5EF4-FFF2-40B4-BE49-F238E27FC236}">
                  <a16:creationId xmlns:a16="http://schemas.microsoft.com/office/drawing/2014/main" id="{7CCF3543-B844-41D5-AC54-9C7794DB1BF3}"/>
                </a:ext>
              </a:extLst>
            </p:cNvPr>
            <p:cNvSpPr/>
            <p:nvPr/>
          </p:nvSpPr>
          <p:spPr>
            <a:xfrm rot="10800000">
              <a:off x="3328317" y="183594"/>
              <a:ext cx="228600" cy="163166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B1CBBAF9-EF2D-4314-A1A5-23D26C827366}"/>
              </a:ext>
            </a:extLst>
          </p:cNvPr>
          <p:cNvSpPr txBox="1"/>
          <p:nvPr/>
        </p:nvSpPr>
        <p:spPr>
          <a:xfrm>
            <a:off x="-48126" y="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771BB3C-B7B4-47B1-92DB-58DB9F16E07E}"/>
              </a:ext>
            </a:extLst>
          </p:cNvPr>
          <p:cNvGrpSpPr/>
          <p:nvPr/>
        </p:nvGrpSpPr>
        <p:grpSpPr>
          <a:xfrm>
            <a:off x="5753577" y="1128281"/>
            <a:ext cx="6144311" cy="3425782"/>
            <a:chOff x="4946618" y="3381273"/>
            <a:chExt cx="6144311" cy="3425782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FE92FBCB-91F0-4767-8F92-D05A90D4353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50474" y="3702812"/>
              <a:ext cx="6140455" cy="144384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B3052605-4297-44C9-9E46-8899167BD0E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50474" y="5363215"/>
              <a:ext cx="6140455" cy="1443840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730FF8F-E9F5-4989-AE50-D583E0D8E8BB}"/>
                </a:ext>
              </a:extLst>
            </p:cNvPr>
            <p:cNvSpPr txBox="1"/>
            <p:nvPr/>
          </p:nvSpPr>
          <p:spPr>
            <a:xfrm>
              <a:off x="4950475" y="3381273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28DBDAE-EE7D-410D-80FC-1CEADA90E1F0}"/>
                </a:ext>
              </a:extLst>
            </p:cNvPr>
            <p:cNvSpPr txBox="1"/>
            <p:nvPr/>
          </p:nvSpPr>
          <p:spPr>
            <a:xfrm>
              <a:off x="4946618" y="503773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B25D765B-F5D1-4667-9627-6DA52558962A}"/>
              </a:ext>
            </a:extLst>
          </p:cNvPr>
          <p:cNvSpPr txBox="1"/>
          <p:nvPr/>
        </p:nvSpPr>
        <p:spPr>
          <a:xfrm>
            <a:off x="5245127" y="-3053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B1B0C5B-EFD3-449C-BC17-71112130F270}"/>
              </a:ext>
            </a:extLst>
          </p:cNvPr>
          <p:cNvGraphicFramePr>
            <a:graphicFrameLocks noGrp="1"/>
          </p:cNvGraphicFramePr>
          <p:nvPr/>
        </p:nvGraphicFramePr>
        <p:xfrm>
          <a:off x="5668474" y="321520"/>
          <a:ext cx="6392999" cy="5486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37634">
                  <a:extLst>
                    <a:ext uri="{9D8B030D-6E8A-4147-A177-3AD203B41FA5}">
                      <a16:colId xmlns:a16="http://schemas.microsoft.com/office/drawing/2014/main" val="559038244"/>
                    </a:ext>
                  </a:extLst>
                </a:gridCol>
                <a:gridCol w="2328087">
                  <a:extLst>
                    <a:ext uri="{9D8B030D-6E8A-4147-A177-3AD203B41FA5}">
                      <a16:colId xmlns:a16="http://schemas.microsoft.com/office/drawing/2014/main" val="3478847516"/>
                    </a:ext>
                  </a:extLst>
                </a:gridCol>
                <a:gridCol w="2827278">
                  <a:extLst>
                    <a:ext uri="{9D8B030D-6E8A-4147-A177-3AD203B41FA5}">
                      <a16:colId xmlns:a16="http://schemas.microsoft.com/office/drawing/2014/main" val="407577897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245176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1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GGCTGAGGCAAGAGAAT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ACAGCACAGTGGGTTCTAA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41185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2 (nested)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CGAAGCTCCATCTCAAA</a:t>
                      </a:r>
                      <a:endParaRPr lang="en-US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GGGAAATGCTGCCTAA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81458508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FD4BB11F-51E6-4228-9D80-51727D990DAA}"/>
              </a:ext>
            </a:extLst>
          </p:cNvPr>
          <p:cNvSpPr txBox="1"/>
          <p:nvPr/>
        </p:nvSpPr>
        <p:spPr>
          <a:xfrm>
            <a:off x="5183838" y="1205225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1672FC5-F0DB-91FB-6C64-22467A5B8EBE}"/>
              </a:ext>
            </a:extLst>
          </p:cNvPr>
          <p:cNvSpPr txBox="1"/>
          <p:nvPr/>
        </p:nvSpPr>
        <p:spPr>
          <a:xfrm>
            <a:off x="8719575" y="6396335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285864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Macintosh PowerPoint</Application>
  <PresentationFormat>Widescreen</PresentationFormat>
  <Paragraphs>2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 Lumibao</dc:creator>
  <cp:lastModifiedBy>Jan Lumibao</cp:lastModifiedBy>
  <cp:revision>1</cp:revision>
  <dcterms:created xsi:type="dcterms:W3CDTF">2022-07-05T18:22:23Z</dcterms:created>
  <dcterms:modified xsi:type="dcterms:W3CDTF">2022-07-05T18:23:04Z</dcterms:modified>
</cp:coreProperties>
</file>